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52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702" autoAdjust="0"/>
  </p:normalViewPr>
  <p:slideViewPr>
    <p:cSldViewPr>
      <p:cViewPr>
        <p:scale>
          <a:sx n="110" d="100"/>
          <a:sy n="110" d="100"/>
        </p:scale>
        <p:origin x="1212" y="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124" y="-90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こむら たくや" userId="7cf7dd3bcc72e149" providerId="LiveId" clId="{8FF248C7-F543-400A-8BA3-E65C7BE1DDF5}"/>
    <pc:docChg chg="undo custSel modSld">
      <pc:chgData name="こむら たくや" userId="7cf7dd3bcc72e149" providerId="LiveId" clId="{8FF248C7-F543-400A-8BA3-E65C7BE1DDF5}" dt="2018-04-19T09:52:26.300" v="80" actId="1076"/>
      <pc:docMkLst>
        <pc:docMk/>
      </pc:docMkLst>
      <pc:sldChg chg="addSp delSp modSp">
        <pc:chgData name="こむら たくや" userId="7cf7dd3bcc72e149" providerId="LiveId" clId="{8FF248C7-F543-400A-8BA3-E65C7BE1DDF5}" dt="2018-04-19T09:52:26.300" v="80" actId="1076"/>
        <pc:sldMkLst>
          <pc:docMk/>
          <pc:sldMk cId="221266230" sldId="352"/>
        </pc:sldMkLst>
        <pc:spChg chg="del">
          <ac:chgData name="こむら たくや" userId="7cf7dd3bcc72e149" providerId="LiveId" clId="{8FF248C7-F543-400A-8BA3-E65C7BE1DDF5}" dt="2018-04-19T09:30:10.832" v="19" actId="478"/>
          <ac:spMkLst>
            <pc:docMk/>
            <pc:sldMk cId="221266230" sldId="352"/>
            <ac:spMk id="7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0.832" v="19" actId="478"/>
          <ac:spMkLst>
            <pc:docMk/>
            <pc:sldMk cId="221266230" sldId="352"/>
            <ac:spMk id="8" creationId="{00000000-0000-0000-0000-000000000000}"/>
          </ac:spMkLst>
        </pc:spChg>
        <pc:spChg chg="del mod topLvl">
          <ac:chgData name="こむら たくや" userId="7cf7dd3bcc72e149" providerId="LiveId" clId="{8FF248C7-F543-400A-8BA3-E65C7BE1DDF5}" dt="2018-04-19T09:30:50.350" v="30" actId="478"/>
          <ac:spMkLst>
            <pc:docMk/>
            <pc:sldMk cId="221266230" sldId="352"/>
            <ac:spMk id="23" creationId="{00000000-0000-0000-0000-000000000000}"/>
          </ac:spMkLst>
        </pc:spChg>
        <pc:spChg chg="del mod topLvl">
          <ac:chgData name="こむら たくや" userId="7cf7dd3bcc72e149" providerId="LiveId" clId="{8FF248C7-F543-400A-8BA3-E65C7BE1DDF5}" dt="2018-04-19T09:30:40.468" v="27" actId="478"/>
          <ac:spMkLst>
            <pc:docMk/>
            <pc:sldMk cId="221266230" sldId="352"/>
            <ac:spMk id="26" creationId="{00000000-0000-0000-0000-000000000000}"/>
          </ac:spMkLst>
        </pc:spChg>
        <pc:spChg chg="del mod topLvl">
          <ac:chgData name="こむら たくや" userId="7cf7dd3bcc72e149" providerId="LiveId" clId="{8FF248C7-F543-400A-8BA3-E65C7BE1DDF5}" dt="2018-04-19T09:30:53.853" v="31" actId="478"/>
          <ac:spMkLst>
            <pc:docMk/>
            <pc:sldMk cId="221266230" sldId="352"/>
            <ac:spMk id="31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3.182" v="20" actId="478"/>
          <ac:spMkLst>
            <pc:docMk/>
            <pc:sldMk cId="221266230" sldId="352"/>
            <ac:spMk id="32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3.182" v="20" actId="478"/>
          <ac:spMkLst>
            <pc:docMk/>
            <pc:sldMk cId="221266230" sldId="352"/>
            <ac:spMk id="33" creationId="{00000000-0000-0000-0000-000000000000}"/>
          </ac:spMkLst>
        </pc:spChg>
        <pc:spChg chg="del mod topLvl">
          <ac:chgData name="こむら たくや" userId="7cf7dd3bcc72e149" providerId="LiveId" clId="{8FF248C7-F543-400A-8BA3-E65C7BE1DDF5}" dt="2018-04-19T09:30:40.468" v="27" actId="478"/>
          <ac:spMkLst>
            <pc:docMk/>
            <pc:sldMk cId="221266230" sldId="352"/>
            <ac:spMk id="34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0.832" v="19" actId="478"/>
          <ac:spMkLst>
            <pc:docMk/>
            <pc:sldMk cId="221266230" sldId="352"/>
            <ac:spMk id="36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0.832" v="19" actId="478"/>
          <ac:spMkLst>
            <pc:docMk/>
            <pc:sldMk cId="221266230" sldId="352"/>
            <ac:spMk id="37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0.832" v="19" actId="478"/>
          <ac:spMkLst>
            <pc:docMk/>
            <pc:sldMk cId="221266230" sldId="352"/>
            <ac:spMk id="40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30.309" v="25" actId="478"/>
          <ac:spMkLst>
            <pc:docMk/>
            <pc:sldMk cId="221266230" sldId="352"/>
            <ac:spMk id="43" creationId="{00000000-0000-0000-0000-000000000000}"/>
          </ac:spMkLst>
        </pc:spChg>
        <pc:spChg chg="del">
          <ac:chgData name="こむら たくや" userId="7cf7dd3bcc72e149" providerId="LiveId" clId="{8FF248C7-F543-400A-8BA3-E65C7BE1DDF5}" dt="2018-04-19T09:30:19.572" v="21" actId="478"/>
          <ac:spMkLst>
            <pc:docMk/>
            <pc:sldMk cId="221266230" sldId="352"/>
            <ac:spMk id="49" creationId="{00000000-0000-0000-0000-000000000000}"/>
          </ac:spMkLst>
        </pc:spChg>
        <pc:spChg chg="mod topLvl">
          <ac:chgData name="こむら たくや" userId="7cf7dd3bcc72e149" providerId="LiveId" clId="{8FF248C7-F543-400A-8BA3-E65C7BE1DDF5}" dt="2018-04-19T09:30:38.091" v="26" actId="165"/>
          <ac:spMkLst>
            <pc:docMk/>
            <pc:sldMk cId="221266230" sldId="352"/>
            <ac:spMk id="51" creationId="{00000000-0000-0000-0000-000000000000}"/>
          </ac:spMkLst>
        </pc:spChg>
        <pc:spChg chg="mod topLvl">
          <ac:chgData name="こむら たくや" userId="7cf7dd3bcc72e149" providerId="LiveId" clId="{8FF248C7-F543-400A-8BA3-E65C7BE1DDF5}" dt="2018-04-19T09:30:45.955" v="28" actId="165"/>
          <ac:spMkLst>
            <pc:docMk/>
            <pc:sldMk cId="221266230" sldId="352"/>
            <ac:spMk id="53" creationId="{00000000-0000-0000-0000-000000000000}"/>
          </ac:spMkLst>
        </pc:spChg>
        <pc:spChg chg="mod">
          <ac:chgData name="こむら たくや" userId="7cf7dd3bcc72e149" providerId="LiveId" clId="{8FF248C7-F543-400A-8BA3-E65C7BE1DDF5}" dt="2018-04-19T09:29:54.409" v="18" actId="20577"/>
          <ac:spMkLst>
            <pc:docMk/>
            <pc:sldMk cId="221266230" sldId="352"/>
            <ac:spMk id="76" creationId="{00000000-0000-0000-0000-000000000000}"/>
          </ac:spMkLst>
        </pc:spChg>
        <pc:grpChg chg="del">
          <ac:chgData name="こむら たくや" userId="7cf7dd3bcc72e149" providerId="LiveId" clId="{8FF248C7-F543-400A-8BA3-E65C7BE1DDF5}" dt="2018-04-19T09:30:45.955" v="28" actId="165"/>
          <ac:grpSpMkLst>
            <pc:docMk/>
            <pc:sldMk cId="221266230" sldId="352"/>
            <ac:grpSpMk id="3" creationId="{2A4D5ED1-B9ED-4E3C-977A-592B72CAFAAD}"/>
          </ac:grpSpMkLst>
        </pc:grpChg>
        <pc:grpChg chg="add del mod">
          <ac:chgData name="こむら たくや" userId="7cf7dd3bcc72e149" providerId="LiveId" clId="{8FF248C7-F543-400A-8BA3-E65C7BE1DDF5}" dt="2018-04-19T09:30:38.091" v="26" actId="165"/>
          <ac:grpSpMkLst>
            <pc:docMk/>
            <pc:sldMk cId="221266230" sldId="352"/>
            <ac:grpSpMk id="4" creationId="{79D54202-BA8D-4067-92AE-7C911BE7FF14}"/>
          </ac:grpSpMkLst>
        </pc:grpChg>
        <pc:grpChg chg="del mod topLvl">
          <ac:chgData name="こむら たくや" userId="7cf7dd3bcc72e149" providerId="LiveId" clId="{8FF248C7-F543-400A-8BA3-E65C7BE1DDF5}" dt="2018-04-19T09:30:40.468" v="27" actId="478"/>
          <ac:grpSpMkLst>
            <pc:docMk/>
            <pc:sldMk cId="221266230" sldId="352"/>
            <ac:grpSpMk id="54" creationId="{00000000-0000-0000-0000-000000000000}"/>
          </ac:grpSpMkLst>
        </pc:grpChg>
        <pc:grpChg chg="del mod topLvl">
          <ac:chgData name="こむら たくや" userId="7cf7dd3bcc72e149" providerId="LiveId" clId="{8FF248C7-F543-400A-8BA3-E65C7BE1DDF5}" dt="2018-04-19T09:30:48.541" v="29" actId="478"/>
          <ac:grpSpMkLst>
            <pc:docMk/>
            <pc:sldMk cId="221266230" sldId="352"/>
            <ac:grpSpMk id="71" creationId="{00000000-0000-0000-0000-000000000000}"/>
          </ac:grpSpMkLst>
        </pc:grpChg>
        <pc:graphicFrameChg chg="del">
          <ac:chgData name="こむら たくや" userId="7cf7dd3bcc72e149" providerId="LiveId" clId="{8FF248C7-F543-400A-8BA3-E65C7BE1DDF5}" dt="2018-04-19T09:30:10.832" v="19" actId="478"/>
          <ac:graphicFrameMkLst>
            <pc:docMk/>
            <pc:sldMk cId="221266230" sldId="352"/>
            <ac:graphicFrameMk id="30" creationId="{00000000-0000-0000-0000-000000000000}"/>
          </ac:graphicFrameMkLst>
        </pc:graphicFrameChg>
        <pc:graphicFrameChg chg="del">
          <ac:chgData name="こむら たくや" userId="7cf7dd3bcc72e149" providerId="LiveId" clId="{8FF248C7-F543-400A-8BA3-E65C7BE1DDF5}" dt="2018-04-19T09:30:10.832" v="19" actId="478"/>
          <ac:graphicFrameMkLst>
            <pc:docMk/>
            <pc:sldMk cId="221266230" sldId="352"/>
            <ac:graphicFrameMk id="35" creationId="{00000000-0000-0000-0000-000000000000}"/>
          </ac:graphicFrameMkLst>
        </pc:graphicFrameChg>
        <pc:graphicFrameChg chg="del mod topLvl">
          <ac:chgData name="こむら たくや" userId="7cf7dd3bcc72e149" providerId="LiveId" clId="{8FF248C7-F543-400A-8BA3-E65C7BE1DDF5}" dt="2018-04-19T09:30:48.541" v="29" actId="478"/>
          <ac:graphicFrameMkLst>
            <pc:docMk/>
            <pc:sldMk cId="221266230" sldId="352"/>
            <ac:graphicFrameMk id="38" creationId="{00000000-0000-0000-0000-000000000000}"/>
          </ac:graphicFrameMkLst>
        </pc:graphicFrameChg>
        <pc:graphicFrameChg chg="del">
          <ac:chgData name="こむら たくや" userId="7cf7dd3bcc72e149" providerId="LiveId" clId="{8FF248C7-F543-400A-8BA3-E65C7BE1DDF5}" dt="2018-04-19T09:30:19.572" v="21" actId="478"/>
          <ac:graphicFrameMkLst>
            <pc:docMk/>
            <pc:sldMk cId="221266230" sldId="352"/>
            <ac:graphicFrameMk id="39" creationId="{00000000-0008-0000-0900-000003000000}"/>
          </ac:graphicFrameMkLst>
        </pc:graphicFrameChg>
        <pc:graphicFrameChg chg="del">
          <ac:chgData name="こむら たくや" userId="7cf7dd3bcc72e149" providerId="LiveId" clId="{8FF248C7-F543-400A-8BA3-E65C7BE1DDF5}" dt="2018-04-19T09:30:25.876" v="24" actId="478"/>
          <ac:graphicFrameMkLst>
            <pc:docMk/>
            <pc:sldMk cId="221266230" sldId="352"/>
            <ac:graphicFrameMk id="41" creationId="{00000000-0000-0000-0000-000000000000}"/>
          </ac:graphicFrameMkLst>
        </pc:graphicFrameChg>
        <pc:graphicFrameChg chg="del">
          <ac:chgData name="こむら たくや" userId="7cf7dd3bcc72e149" providerId="LiveId" clId="{8FF248C7-F543-400A-8BA3-E65C7BE1DDF5}" dt="2018-04-19T09:30:19.572" v="21" actId="478"/>
          <ac:graphicFrameMkLst>
            <pc:docMk/>
            <pc:sldMk cId="221266230" sldId="352"/>
            <ac:graphicFrameMk id="42" creationId="{00000000-0008-0000-0300-000003000000}"/>
          </ac:graphicFrameMkLst>
        </pc:graphicFrameChg>
        <pc:graphicFrameChg chg="add mod modGraphic">
          <ac:chgData name="こむら たくや" userId="7cf7dd3bcc72e149" providerId="LiveId" clId="{8FF248C7-F543-400A-8BA3-E65C7BE1DDF5}" dt="2018-04-19T09:50:16.623" v="68" actId="1076"/>
          <ac:graphicFrameMkLst>
            <pc:docMk/>
            <pc:sldMk cId="221266230" sldId="352"/>
            <ac:graphicFrameMk id="44" creationId="{A9C451D8-0859-400C-8443-4A8DDE556E12}"/>
          </ac:graphicFrameMkLst>
        </pc:graphicFrameChg>
        <pc:graphicFrameChg chg="add mod">
          <ac:chgData name="こむら たくや" userId="7cf7dd3bcc72e149" providerId="LiveId" clId="{8FF248C7-F543-400A-8BA3-E65C7BE1DDF5}" dt="2018-04-19T09:52:26.300" v="80" actId="1076"/>
          <ac:graphicFrameMkLst>
            <pc:docMk/>
            <pc:sldMk cId="221266230" sldId="352"/>
            <ac:graphicFrameMk id="45" creationId="{310ADBF3-DCF5-4DA9-BDE9-04D1C5E58E8B}"/>
          </ac:graphicFrameMkLst>
        </pc:graphicFrameChg>
        <pc:graphicFrameChg chg="add mod">
          <ac:chgData name="こむら たくや" userId="7cf7dd3bcc72e149" providerId="LiveId" clId="{8FF248C7-F543-400A-8BA3-E65C7BE1DDF5}" dt="2018-04-19T09:52:23.989" v="79" actId="1076"/>
          <ac:graphicFrameMkLst>
            <pc:docMk/>
            <pc:sldMk cId="221266230" sldId="352"/>
            <ac:graphicFrameMk id="46" creationId="{EFCA0EEF-1092-4799-9FE5-F7176D6A06CC}"/>
          </ac:graphicFrameMkLst>
        </pc:graphicFrameChg>
        <pc:graphicFrameChg chg="add mod modGraphic">
          <ac:chgData name="こむら たくや" userId="7cf7dd3bcc72e149" providerId="LiveId" clId="{8FF248C7-F543-400A-8BA3-E65C7BE1DDF5}" dt="2018-04-19T09:52:17.812" v="78" actId="20577"/>
          <ac:graphicFrameMkLst>
            <pc:docMk/>
            <pc:sldMk cId="221266230" sldId="352"/>
            <ac:graphicFrameMk id="47" creationId="{2AF29D07-E60F-4DE7-AE0C-2B28E406AD84}"/>
          </ac:graphicFrameMkLst>
        </pc:graphicFrameChg>
      </pc:sldChg>
    </pc:docChg>
  </pc:docChgLst>
  <pc:docChgLst>
    <pc:chgData name="こむらたくや" userId="7cf7dd3bcc72e149" providerId="LiveId" clId="{91EF50D1-7F43-4800-9488-C350E7C173D4}"/>
  </pc:docChgLst>
  <pc:docChgLst>
    <pc:chgData name="こむらたくや" userId="7cf7dd3bcc72e149" providerId="LiveId" clId="{951566A1-1D92-479B-AA9C-21BEB5B7373D}"/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2823;&#33144;&#30284;&#12288;&#32966;&#31649;&#12364;&#12435;&#12288;&#34880;&#28165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5!$A$76</c:f>
              <c:strCache>
                <c:ptCount val="1"/>
                <c:pt idx="0">
                  <c:v>平　均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30F-4B72-88E8-2A9BEA281CE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30F-4B72-88E8-2A9BEA281CE7}"/>
              </c:ext>
            </c:extLst>
          </c:dPt>
          <c:errBars>
            <c:errBarType val="plus"/>
            <c:errValType val="cust"/>
            <c:noEndCap val="0"/>
            <c:plus>
              <c:numRef>
                <c:f>Sheet25!$B$77:$C$77</c:f>
                <c:numCache>
                  <c:formatCode>General</c:formatCode>
                  <c:ptCount val="2"/>
                  <c:pt idx="0">
                    <c:v>4.5703001737479845</c:v>
                  </c:pt>
                  <c:pt idx="1">
                    <c:v>5.6580232867342861</c:v>
                  </c:pt>
                </c:numCache>
              </c:numRef>
            </c:plus>
          </c:errBars>
          <c:cat>
            <c:strRef>
              <c:f>Sheet25!$B$75:$C$75</c:f>
              <c:strCache>
                <c:ptCount val="2"/>
                <c:pt idx="0">
                  <c:v>colon ca</c:v>
                </c:pt>
                <c:pt idx="1">
                  <c:v>Healthy</c:v>
                </c:pt>
              </c:strCache>
            </c:strRef>
          </c:cat>
          <c:val>
            <c:numRef>
              <c:f>Sheet25!$B$76:$C$76</c:f>
              <c:numCache>
                <c:formatCode>0.000</c:formatCode>
                <c:ptCount val="2"/>
                <c:pt idx="0">
                  <c:v>25.316666666666666</c:v>
                </c:pt>
                <c:pt idx="1">
                  <c:v>24.5714285714285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30F-4B72-88E8-2A9BEA281C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68331904"/>
        <c:axId val="168333696"/>
      </c:barChart>
      <c:catAx>
        <c:axId val="16833190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low"/>
        <c:crossAx val="168333696"/>
        <c:crosses val="autoZero"/>
        <c:auto val="1"/>
        <c:lblAlgn val="ctr"/>
        <c:lblOffset val="100"/>
        <c:noMultiLvlLbl val="0"/>
      </c:catAx>
      <c:valAx>
        <c:axId val="16833369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6833190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6!$A$76</c:f>
              <c:strCache>
                <c:ptCount val="1"/>
                <c:pt idx="0">
                  <c:v>平　均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FA2-4C90-ACDE-1029548CA7F1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FA2-4C90-ACDE-1029548CA7F1}"/>
              </c:ext>
            </c:extLst>
          </c:dPt>
          <c:errBars>
            <c:errBarType val="plus"/>
            <c:errValType val="cust"/>
            <c:noEndCap val="0"/>
            <c:plus>
              <c:numRef>
                <c:f>Sheet26!$B$77:$C$77</c:f>
                <c:numCache>
                  <c:formatCode>General</c:formatCode>
                  <c:ptCount val="2"/>
                  <c:pt idx="0">
                    <c:v>13.105794319996958</c:v>
                  </c:pt>
                  <c:pt idx="1">
                    <c:v>12.190507192420899</c:v>
                  </c:pt>
                </c:numCache>
              </c:numRef>
            </c:plus>
          </c:errBars>
          <c:cat>
            <c:strRef>
              <c:f>Sheet26!$B$75:$C$75</c:f>
              <c:strCache>
                <c:ptCount val="2"/>
                <c:pt idx="0">
                  <c:v>colon ca</c:v>
                </c:pt>
                <c:pt idx="1">
                  <c:v>Healthy</c:v>
                </c:pt>
              </c:strCache>
            </c:strRef>
          </c:cat>
          <c:val>
            <c:numRef>
              <c:f>Sheet26!$B$76:$C$76</c:f>
              <c:numCache>
                <c:formatCode>0.000</c:formatCode>
                <c:ptCount val="2"/>
                <c:pt idx="0">
                  <c:v>28.359375</c:v>
                </c:pt>
                <c:pt idx="1">
                  <c:v>29.3571428571428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FA2-4C90-ACDE-1029548CA7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8424448"/>
        <c:axId val="158442624"/>
      </c:barChart>
      <c:catAx>
        <c:axId val="15842444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low"/>
        <c:crossAx val="158442624"/>
        <c:crosses val="autoZero"/>
        <c:auto val="1"/>
        <c:lblAlgn val="ctr"/>
        <c:lblOffset val="100"/>
        <c:noMultiLvlLbl val="0"/>
      </c:catAx>
      <c:valAx>
        <c:axId val="15844262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8424448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7!$A$76</c:f>
              <c:strCache>
                <c:ptCount val="1"/>
                <c:pt idx="0">
                  <c:v>平　均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EBD-4C56-9152-754E24CF043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EBD-4C56-9152-754E24CF043D}"/>
              </c:ext>
            </c:extLst>
          </c:dPt>
          <c:errBars>
            <c:errBarType val="plus"/>
            <c:errValType val="cust"/>
            <c:noEndCap val="0"/>
            <c:plus>
              <c:numRef>
                <c:f>Sheet27!$B$77:$C$77</c:f>
                <c:numCache>
                  <c:formatCode>General</c:formatCode>
                  <c:ptCount val="2"/>
                  <c:pt idx="0">
                    <c:v>22.520259078561189</c:v>
                  </c:pt>
                  <c:pt idx="1">
                    <c:v>31.995964320586321</c:v>
                  </c:pt>
                </c:numCache>
              </c:numRef>
            </c:plus>
          </c:errBars>
          <c:cat>
            <c:strRef>
              <c:f>Sheet27!$B$75:$C$75</c:f>
              <c:strCache>
                <c:ptCount val="2"/>
                <c:pt idx="0">
                  <c:v>colon ca</c:v>
                </c:pt>
                <c:pt idx="1">
                  <c:v>Healthy</c:v>
                </c:pt>
              </c:strCache>
            </c:strRef>
          </c:cat>
          <c:val>
            <c:numRef>
              <c:f>Sheet27!$B$76:$C$76</c:f>
              <c:numCache>
                <c:formatCode>0.000</c:formatCode>
                <c:ptCount val="2"/>
                <c:pt idx="0">
                  <c:v>77.099999999999994</c:v>
                </c:pt>
                <c:pt idx="1">
                  <c:v>77.160714285714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BD-4C56-9152-754E24CF04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45788928"/>
        <c:axId val="145792000"/>
      </c:barChart>
      <c:catAx>
        <c:axId val="14578892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low"/>
        <c:crossAx val="145792000"/>
        <c:crosses val="autoZero"/>
        <c:auto val="1"/>
        <c:lblAlgn val="ctr"/>
        <c:lblOffset val="100"/>
        <c:noMultiLvlLbl val="0"/>
      </c:catAx>
      <c:valAx>
        <c:axId val="14579200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5788928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8!$A$76</c:f>
              <c:strCache>
                <c:ptCount val="1"/>
                <c:pt idx="0">
                  <c:v>平　均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CB4E-4415-A3A1-99D2E0EE25D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B4E-4415-A3A1-99D2E0EE25D5}"/>
              </c:ext>
            </c:extLst>
          </c:dPt>
          <c:errBars>
            <c:errBarType val="plus"/>
            <c:errValType val="cust"/>
            <c:noEndCap val="0"/>
            <c:plus>
              <c:numRef>
                <c:f>Sheet28!$B$77:$C$77</c:f>
                <c:numCache>
                  <c:formatCode>General</c:formatCode>
                  <c:ptCount val="2"/>
                  <c:pt idx="0">
                    <c:v>53.500738527505455</c:v>
                  </c:pt>
                  <c:pt idx="1">
                    <c:v>53.643206323411398</c:v>
                  </c:pt>
                </c:numCache>
              </c:numRef>
            </c:plus>
          </c:errBars>
          <c:cat>
            <c:strRef>
              <c:f>Sheet28!$B$75:$C$75</c:f>
              <c:strCache>
                <c:ptCount val="2"/>
                <c:pt idx="0">
                  <c:v>colon ca</c:v>
                </c:pt>
                <c:pt idx="1">
                  <c:v>Healthy</c:v>
                </c:pt>
              </c:strCache>
            </c:strRef>
          </c:cat>
          <c:val>
            <c:numRef>
              <c:f>Sheet28!$B$76:$C$76</c:f>
              <c:numCache>
                <c:formatCode>0.000</c:formatCode>
                <c:ptCount val="2"/>
                <c:pt idx="0">
                  <c:v>103.58333333333333</c:v>
                </c:pt>
                <c:pt idx="1">
                  <c:v>94.5892857142857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B4E-4415-A3A1-99D2E0EE25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00477952"/>
        <c:axId val="145785600"/>
      </c:barChart>
      <c:catAx>
        <c:axId val="1004779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low"/>
        <c:crossAx val="145785600"/>
        <c:crosses val="autoZero"/>
        <c:auto val="1"/>
        <c:lblAlgn val="ctr"/>
        <c:lblOffset val="100"/>
        <c:noMultiLvlLbl val="0"/>
      </c:catAx>
      <c:valAx>
        <c:axId val="14578560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00477952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62F910-E5ED-462D-9609-C419E481E427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021FB-4680-467A-980F-69BDF8F16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49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NF-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8666FB-0113-4578-B266-0D791D004B5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883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25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11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19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649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841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59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97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574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6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81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88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7E943-3E43-4981-AC6D-9EF73F50FE6F}" type="datetimeFigureOut">
              <a:rPr kumimoji="1" lang="ja-JP" altLang="en-US" smtClean="0"/>
              <a:t>2018/4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324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691969" y="-835076"/>
            <a:ext cx="7601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4825562" y="476672"/>
            <a:ext cx="50526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7089402" y="517902"/>
            <a:ext cx="50526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2574545" y="476672"/>
            <a:ext cx="49244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正方形/長方形 52"/>
          <p:cNvSpPr/>
          <p:nvPr/>
        </p:nvSpPr>
        <p:spPr>
          <a:xfrm>
            <a:off x="323528" y="476672"/>
            <a:ext cx="49244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正方形/長方形 75"/>
          <p:cNvSpPr/>
          <p:nvPr/>
        </p:nvSpPr>
        <p:spPr>
          <a:xfrm>
            <a:off x="172821" y="152162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22CBC60-430F-4F47-891B-EFB2684EF302}"/>
              </a:ext>
            </a:extLst>
          </p:cNvPr>
          <p:cNvSpPr/>
          <p:nvPr/>
        </p:nvSpPr>
        <p:spPr>
          <a:xfrm>
            <a:off x="124877" y="868567"/>
            <a:ext cx="6222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DF6211AB-2B9E-4BBF-8A59-DFFF30565886}"/>
              </a:ext>
            </a:extLst>
          </p:cNvPr>
          <p:cNvSpPr/>
          <p:nvPr/>
        </p:nvSpPr>
        <p:spPr>
          <a:xfrm>
            <a:off x="755576" y="868567"/>
            <a:ext cx="856325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269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5895537"/>
              </p:ext>
            </p:extLst>
          </p:nvPr>
        </p:nvGraphicFramePr>
        <p:xfrm>
          <a:off x="255464" y="1246223"/>
          <a:ext cx="171581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0358435"/>
              </p:ext>
            </p:extLst>
          </p:nvPr>
        </p:nvGraphicFramePr>
        <p:xfrm>
          <a:off x="2538530" y="1246223"/>
          <a:ext cx="171581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024995"/>
              </p:ext>
            </p:extLst>
          </p:nvPr>
        </p:nvGraphicFramePr>
        <p:xfrm>
          <a:off x="7104662" y="1246223"/>
          <a:ext cx="171581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4932813"/>
              </p:ext>
            </p:extLst>
          </p:nvPr>
        </p:nvGraphicFramePr>
        <p:xfrm>
          <a:off x="4821596" y="1246223"/>
          <a:ext cx="171581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9FEB01F4-CF08-45A4-9F7E-AF03CEB8A146}"/>
              </a:ext>
            </a:extLst>
          </p:cNvPr>
          <p:cNvSpPr/>
          <p:nvPr/>
        </p:nvSpPr>
        <p:spPr>
          <a:xfrm>
            <a:off x="691969" y="3713169"/>
            <a:ext cx="12157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RC   Health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BAD3D0F-1CA0-4790-8C4B-9B39A61ECDEE}"/>
              </a:ext>
            </a:extLst>
          </p:cNvPr>
          <p:cNvSpPr/>
          <p:nvPr/>
        </p:nvSpPr>
        <p:spPr>
          <a:xfrm>
            <a:off x="827584" y="548680"/>
            <a:ext cx="78098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n-US" altLang="ja-JP" sz="16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ja-JP" altLang="en-US" sz="16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E6214EAF-6407-416B-ABE5-820B7E465D82}"/>
              </a:ext>
            </a:extLst>
          </p:cNvPr>
          <p:cNvSpPr/>
          <p:nvPr/>
        </p:nvSpPr>
        <p:spPr>
          <a:xfrm>
            <a:off x="3203848" y="548680"/>
            <a:ext cx="6687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ja-JP" sz="16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lang="ja-JP" altLang="en-US" sz="16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A0AE1386-CD3B-4C98-869D-281A28C41863}"/>
              </a:ext>
            </a:extLst>
          </p:cNvPr>
          <p:cNvSpPr/>
          <p:nvPr/>
        </p:nvSpPr>
        <p:spPr>
          <a:xfrm>
            <a:off x="5436096" y="548680"/>
            <a:ext cx="6527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ja-JP" altLang="en-US" sz="16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CF6D67D3-61E9-453E-9108-AF0450CF8C4E}"/>
              </a:ext>
            </a:extLst>
          </p:cNvPr>
          <p:cNvSpPr/>
          <p:nvPr/>
        </p:nvSpPr>
        <p:spPr>
          <a:xfrm>
            <a:off x="7777639" y="548680"/>
            <a:ext cx="6527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  <a:endParaRPr lang="ja-JP" altLang="en-US" sz="16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B3862447-068B-4F8B-AF84-55E98AAEF86F}"/>
              </a:ext>
            </a:extLst>
          </p:cNvPr>
          <p:cNvSpPr/>
          <p:nvPr/>
        </p:nvSpPr>
        <p:spPr>
          <a:xfrm>
            <a:off x="2365538" y="868567"/>
            <a:ext cx="6222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54B93828-6000-46FB-96EB-B943538675AC}"/>
              </a:ext>
            </a:extLst>
          </p:cNvPr>
          <p:cNvSpPr/>
          <p:nvPr/>
        </p:nvSpPr>
        <p:spPr>
          <a:xfrm>
            <a:off x="4669794" y="868567"/>
            <a:ext cx="6222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0F38061A-4289-476E-8F81-5B7F4F6B24DD}"/>
              </a:ext>
            </a:extLst>
          </p:cNvPr>
          <p:cNvSpPr/>
          <p:nvPr/>
        </p:nvSpPr>
        <p:spPr>
          <a:xfrm>
            <a:off x="6974050" y="868567"/>
            <a:ext cx="62228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2C0327E8-65BF-4FCD-85B9-EE1EFD346551}"/>
              </a:ext>
            </a:extLst>
          </p:cNvPr>
          <p:cNvSpPr/>
          <p:nvPr/>
        </p:nvSpPr>
        <p:spPr>
          <a:xfrm>
            <a:off x="3110372" y="868567"/>
            <a:ext cx="856325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855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1C4ADE3C-59D7-49A8-8F14-208F6DC72D3F}"/>
              </a:ext>
            </a:extLst>
          </p:cNvPr>
          <p:cNvSpPr/>
          <p:nvPr/>
        </p:nvSpPr>
        <p:spPr>
          <a:xfrm>
            <a:off x="5355589" y="868567"/>
            <a:ext cx="856325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787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B27AF12C-733D-4AB6-B746-4A12E0BCDA86}"/>
              </a:ext>
            </a:extLst>
          </p:cNvPr>
          <p:cNvSpPr/>
          <p:nvPr/>
        </p:nvSpPr>
        <p:spPr>
          <a:xfrm>
            <a:off x="7675847" y="868567"/>
            <a:ext cx="856325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70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6F71ADC5-1392-4E74-8144-9B46A773F644}"/>
              </a:ext>
            </a:extLst>
          </p:cNvPr>
          <p:cNvCxnSpPr/>
          <p:nvPr/>
        </p:nvCxnSpPr>
        <p:spPr>
          <a:xfrm>
            <a:off x="569749" y="3672123"/>
            <a:ext cx="133795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3E87E5B6-E239-4843-A043-5E8C52863F73}"/>
              </a:ext>
            </a:extLst>
          </p:cNvPr>
          <p:cNvCxnSpPr/>
          <p:nvPr/>
        </p:nvCxnSpPr>
        <p:spPr>
          <a:xfrm>
            <a:off x="2843808" y="3672123"/>
            <a:ext cx="133795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B2940667-20CA-4F30-97E5-71C011787D37}"/>
              </a:ext>
            </a:extLst>
          </p:cNvPr>
          <p:cNvCxnSpPr/>
          <p:nvPr/>
        </p:nvCxnSpPr>
        <p:spPr>
          <a:xfrm>
            <a:off x="5199451" y="3672123"/>
            <a:ext cx="133795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EB7B2443-E75F-411E-A1C5-865DEA0A0D14}"/>
              </a:ext>
            </a:extLst>
          </p:cNvPr>
          <p:cNvCxnSpPr/>
          <p:nvPr/>
        </p:nvCxnSpPr>
        <p:spPr>
          <a:xfrm>
            <a:off x="7482517" y="3672123"/>
            <a:ext cx="133795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86A2CE08-1303-4228-8DC6-D81D22640FB2}"/>
              </a:ext>
            </a:extLst>
          </p:cNvPr>
          <p:cNvSpPr/>
          <p:nvPr/>
        </p:nvSpPr>
        <p:spPr>
          <a:xfrm>
            <a:off x="2996225" y="3713169"/>
            <a:ext cx="12157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RC   Health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9D011A8C-C35C-436D-BE72-9059050DB3E4}"/>
              </a:ext>
            </a:extLst>
          </p:cNvPr>
          <p:cNvSpPr/>
          <p:nvPr/>
        </p:nvSpPr>
        <p:spPr>
          <a:xfrm>
            <a:off x="5292080" y="3713169"/>
            <a:ext cx="12157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RC   Health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D67AFC40-29B3-4451-AC30-47B0AA821863}"/>
              </a:ext>
            </a:extLst>
          </p:cNvPr>
          <p:cNvSpPr/>
          <p:nvPr/>
        </p:nvSpPr>
        <p:spPr>
          <a:xfrm>
            <a:off x="7604737" y="3713169"/>
            <a:ext cx="121573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RC   Health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266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66</TotalTime>
  <Words>65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Takuya Komura</cp:lastModifiedBy>
  <cp:revision>321</cp:revision>
  <dcterms:created xsi:type="dcterms:W3CDTF">2012-12-02T10:47:32Z</dcterms:created>
  <dcterms:modified xsi:type="dcterms:W3CDTF">2018-04-20T14:17:12Z</dcterms:modified>
</cp:coreProperties>
</file>